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보통 스타일 2 - 강조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3" d="100"/>
          <a:sy n="93" d="100"/>
        </p:scale>
        <p:origin x="2790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5895C1-E683-467D-B831-55EA236273D9}" type="datetimeFigureOut">
              <a:rPr lang="ko-KR" altLang="en-US" smtClean="0"/>
              <a:t>2018-06-0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0FE57E-935D-4C0A-BE7B-82EA90E720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80502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Rectangle 1"/>
          <p:cNvSpPr>
            <a:spLocks noChangeArrowheads="1"/>
          </p:cNvSpPr>
          <p:nvPr/>
        </p:nvSpPr>
        <p:spPr bwMode="auto">
          <a:xfrm>
            <a:off x="1772814" y="1458196"/>
            <a:ext cx="3672408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바탕" pitchFamily="18" charset="-127"/>
                <a:cs typeface="Arial" pitchFamily="34" charset="0"/>
              </a:rPr>
              <a:t>Target 1 : 5’-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바탕" pitchFamily="18" charset="-127"/>
                <a:cs typeface="Arial" pitchFamily="34" charset="0"/>
              </a:rPr>
              <a:t>CTGCAAGACTATCGACATGGAGCTG-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바탕" pitchFamily="18" charset="-127"/>
                <a:cs typeface="Arial" pitchFamily="34" charset="0"/>
              </a:rPr>
              <a:t>3’ </a:t>
            </a:r>
            <a:endParaRPr kumimoji="1" lang="en-US" altLang="ko-K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바탕" pitchFamily="18" charset="-127"/>
                <a:cs typeface="Arial" pitchFamily="34" charset="0"/>
              </a:rPr>
              <a:t>Target 2 : 5’-</a:t>
            </a: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바탕" pitchFamily="18" charset="-127"/>
                <a:cs typeface="Arial" pitchFamily="34" charset="0"/>
              </a:rPr>
              <a:t>ACCAGAAATACAGCAACAATTCCTG-</a:t>
            </a:r>
            <a:r>
              <a:rPr kumimoji="1" lang="en-US" altLang="ko-K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바탕" pitchFamily="18" charset="-127"/>
                <a:cs typeface="Arial" pitchFamily="34" charset="0"/>
              </a:rPr>
              <a:t>3’</a:t>
            </a:r>
            <a:endParaRPr kumimoji="1" lang="en-US" altLang="ko-KR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바탕" pitchFamily="18" charset="-127"/>
                <a:cs typeface="Arial" pitchFamily="34" charset="0"/>
              </a:rPr>
              <a:t>Target 3 : 5’-CACCAACTATTGCTTCAGCTCCACG-3’</a:t>
            </a:r>
            <a:endParaRPr kumimoji="1" lang="en-US" altLang="ko-K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1844822" y="4482732"/>
            <a:ext cx="3384376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Target 1: 5’-GTGATTTCCATCTACAACAGCACCA-3’</a:t>
            </a:r>
          </a:p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Target 2 : 5’-CTTCAGAATTGTTCGATTTGACGTC-3’</a:t>
            </a:r>
          </a:p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Target 3: 5’-GGATTGAGCTATATCAGATTCTCAA-3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’</a:t>
            </a:r>
          </a:p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Target 4 : 5’-CACTTTACATTGATTTCAAGAGGGA-3’</a:t>
            </a:r>
          </a:p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Target 5 : 5’-CTTATATAATACCATAAATCCAGAA-3’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80726" y="130071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A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82551" y="426054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" name="표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6493944"/>
              </p:ext>
            </p:extLst>
          </p:nvPr>
        </p:nvGraphicFramePr>
        <p:xfrm>
          <a:off x="1340767" y="5464802"/>
          <a:ext cx="4320481" cy="2275550"/>
        </p:xfrm>
        <a:graphic>
          <a:graphicData uri="http://schemas.openxmlformats.org/drawingml/2006/table">
            <a:tbl>
              <a:tblPr/>
              <a:tblGrid>
                <a:gridCol w="1010975"/>
                <a:gridCol w="515024"/>
                <a:gridCol w="515024"/>
                <a:gridCol w="515024"/>
                <a:gridCol w="515024"/>
                <a:gridCol w="515024"/>
                <a:gridCol w="734386"/>
              </a:tblGrid>
              <a:tr h="2176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R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im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∆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∆∆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800" b="1" i="0" u="none" strike="noStrike" baseline="30000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∆∆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eduction 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9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76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crambled 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R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imen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1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0.7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negative control)</a:t>
                      </a:r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6.94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96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ntrol - </a:t>
                      </a:r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vimen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7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positive control)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imen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4.0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3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.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5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16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-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4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72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32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36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95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0.52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-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5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85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27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3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02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9.834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-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1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9.7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.52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56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085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1.52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-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6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7.9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3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35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92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0.77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-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4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.06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57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6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2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7.240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2" name="표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64275"/>
              </p:ext>
            </p:extLst>
          </p:nvPr>
        </p:nvGraphicFramePr>
        <p:xfrm>
          <a:off x="1340768" y="2152434"/>
          <a:ext cx="4248471" cy="1749770"/>
        </p:xfrm>
        <a:graphic>
          <a:graphicData uri="http://schemas.openxmlformats.org/drawingml/2006/table">
            <a:tbl>
              <a:tblPr/>
              <a:tblGrid>
                <a:gridCol w="994124"/>
                <a:gridCol w="506440"/>
                <a:gridCol w="506440"/>
                <a:gridCol w="506440"/>
                <a:gridCol w="506440"/>
                <a:gridCol w="506440"/>
                <a:gridCol w="722147"/>
              </a:tblGrid>
              <a:tr h="2176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R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ime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∆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∆∆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baseline="0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r>
                        <a:rPr lang="en-US" sz="800" b="1" i="0" u="none" strike="noStrike" baseline="30000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∆∆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eduction 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.4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76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crambled 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R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imen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0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6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negative control)</a:t>
                      </a:r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l-G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9.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.5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ontrol - </a:t>
                      </a:r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vimen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47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positive control)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imen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5.25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7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.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.05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4.16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r>
                        <a:rPr lang="el-G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.7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l-GR" altLang="ko-KR" sz="8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2.2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5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0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37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6.34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-sh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66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2.44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.7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28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03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9.705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r>
                        <a:rPr lang="el-G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h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0.99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2922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TGF-</a:t>
                      </a:r>
                      <a:r>
                        <a:rPr lang="el-GR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l-GR" altLang="ko-KR" sz="8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3.41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.42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92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264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3.575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88640" y="323528"/>
            <a:ext cx="1346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. Fig. 1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5</TotalTime>
  <Words>254</Words>
  <Application>Microsoft Office PowerPoint</Application>
  <PresentationFormat>화면 슬라이드 쇼(4:3)</PresentationFormat>
  <Paragraphs>20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굴림</vt:lpstr>
      <vt:lpstr>맑은 고딕</vt:lpstr>
      <vt:lpstr>바탕</vt:lpstr>
      <vt:lpstr>Arial</vt:lpstr>
      <vt:lpstr>Office 테마</vt:lpstr>
      <vt:lpstr>PowerPoint 프레젠테이션</vt:lpstr>
    </vt:vector>
  </TitlesOfParts>
  <Company>severan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js109</dc:creator>
  <cp:lastModifiedBy>송재진(의생명과학부)</cp:lastModifiedBy>
  <cp:revision>85</cp:revision>
  <cp:lastPrinted>2018-06-01T07:55:06Z</cp:lastPrinted>
  <dcterms:created xsi:type="dcterms:W3CDTF">2017-09-09T11:44:52Z</dcterms:created>
  <dcterms:modified xsi:type="dcterms:W3CDTF">2018-06-04T05:18:44Z</dcterms:modified>
</cp:coreProperties>
</file>